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463" r:id="rId2"/>
    <p:sldId id="472" r:id="rId3"/>
    <p:sldId id="471" r:id="rId4"/>
    <p:sldId id="452" r:id="rId5"/>
    <p:sldId id="470" r:id="rId6"/>
    <p:sldId id="453" r:id="rId7"/>
    <p:sldId id="468" r:id="rId8"/>
  </p:sldIdLst>
  <p:sldSz cx="6858000" cy="9906000" type="A4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AB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091" autoAdjust="0"/>
    <p:restoredTop sz="95827" autoAdjust="0"/>
  </p:normalViewPr>
  <p:slideViewPr>
    <p:cSldViewPr snapToGrid="0">
      <p:cViewPr>
        <p:scale>
          <a:sx n="72" d="100"/>
          <a:sy n="72" d="100"/>
        </p:scale>
        <p:origin x="-784" y="736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hopkins\Dropbox\DropBOX%20Shared%20Work%20Files\RNA-seq\Ingenuity%20Analysis%20(FDR%20uunder%200.05,%20ratio%201.25)\Summary%20Data%20for%20paper%20figures%20(whole%20RNA-seq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hopkins\Dropbox\DropBOX%20Shared%20Work%20Files\RNA-seq\Ingenuity%20Analysis%20(FDR%20uunder%200.05,%20ratio%201.25)\Summary%20Data%20for%20paper%20figures%20(whole%20RNA-seq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3"/>
    </mc:Choice>
    <mc:Fallback>
      <c:style val="33"/>
    </mc:Fallback>
  </mc:AlternateContent>
  <c:chart>
    <c:title>
      <c:tx>
        <c:rich>
          <a:bodyPr/>
          <a:lstStyle/>
          <a:p>
            <a:pPr>
              <a:defRPr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000" b="0">
                <a:latin typeface="Arial" panose="020B0604020202020204" pitchFamily="34" charset="0"/>
                <a:cs typeface="Arial" panose="020B0604020202020204" pitchFamily="34" charset="0"/>
              </a:rPr>
              <a:t>-log(BH-corrected </a:t>
            </a:r>
            <a:r>
              <a:rPr lang="en-US" sz="1000" b="0" i="1">
                <a:latin typeface="Arial" panose="020B0604020202020204" pitchFamily="34" charset="0"/>
                <a:cs typeface="Arial" panose="020B0604020202020204" pitchFamily="34" charset="0"/>
              </a:rPr>
              <a:t>p-value</a:t>
            </a:r>
            <a:r>
              <a:rPr lang="en-US" sz="1000" b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c:rich>
      </c:tx>
      <c:layout>
        <c:manualLayout>
          <c:xMode val="edge"/>
          <c:yMode val="edge"/>
          <c:x val="0.482169689651023"/>
          <c:y val="0.0017496917896769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502927205719109"/>
          <c:y val="0.133755137433947"/>
          <c:w val="0.210527094235857"/>
          <c:h val="0.831659910236831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Molecular and Cellular Function'!$F$3</c:f>
              <c:strCache>
                <c:ptCount val="1"/>
                <c:pt idx="0">
                  <c:v>-log(BH-corrected p-value)</c:v>
                </c:pt>
              </c:strCache>
            </c:strRef>
          </c:tx>
          <c:invertIfNegative val="0"/>
          <c:cat>
            <c:strRef>
              <c:f>'Molecular and Cellular Function'!$E$4:$E$19</c:f>
              <c:strCache>
                <c:ptCount val="16"/>
                <c:pt idx="0">
                  <c:v>Cellular Growth and Proliferation</c:v>
                </c:pt>
                <c:pt idx="1">
                  <c:v>Cell Death and Survival</c:v>
                </c:pt>
                <c:pt idx="2">
                  <c:v>Post-Translational Modification</c:v>
                </c:pt>
                <c:pt idx="3">
                  <c:v>Cellular Assembly and Organization</c:v>
                </c:pt>
                <c:pt idx="4">
                  <c:v>Cellular Function and Maintenance</c:v>
                </c:pt>
                <c:pt idx="5">
                  <c:v>Gene Expression</c:v>
                </c:pt>
                <c:pt idx="6">
                  <c:v>Cell Cycle</c:v>
                </c:pt>
                <c:pt idx="7">
                  <c:v>Cellular Movement</c:v>
                </c:pt>
                <c:pt idx="8">
                  <c:v>Cellular Development</c:v>
                </c:pt>
                <c:pt idx="9">
                  <c:v>Cell Signalling</c:v>
                </c:pt>
                <c:pt idx="10">
                  <c:v>Protein Degradation</c:v>
                </c:pt>
                <c:pt idx="11">
                  <c:v>Protein Synthesis</c:v>
                </c:pt>
                <c:pt idx="12">
                  <c:v>Cellular Compromise</c:v>
                </c:pt>
                <c:pt idx="13">
                  <c:v>DNA Rep., Recomb. and Repair</c:v>
                </c:pt>
                <c:pt idx="14">
                  <c:v>Cell Morphology</c:v>
                </c:pt>
                <c:pt idx="15">
                  <c:v>Cell-To-Cell Signalling and Interaction</c:v>
                </c:pt>
              </c:strCache>
            </c:strRef>
          </c:cat>
          <c:val>
            <c:numRef>
              <c:f>'Molecular and Cellular Function'!$F$4:$F$19</c:f>
              <c:numCache>
                <c:formatCode>General</c:formatCode>
                <c:ptCount val="16"/>
                <c:pt idx="0">
                  <c:v>6.165579296318401</c:v>
                </c:pt>
                <c:pt idx="1">
                  <c:v>5.44129142946684</c:v>
                </c:pt>
                <c:pt idx="2">
                  <c:v>5.207608310501746</c:v>
                </c:pt>
                <c:pt idx="3">
                  <c:v>4.892790030352131</c:v>
                </c:pt>
                <c:pt idx="4">
                  <c:v>4.892790030352131</c:v>
                </c:pt>
                <c:pt idx="5">
                  <c:v>4.80966830182971</c:v>
                </c:pt>
                <c:pt idx="6">
                  <c:v>4.467245621007502</c:v>
                </c:pt>
                <c:pt idx="7">
                  <c:v>3.815308569182401</c:v>
                </c:pt>
                <c:pt idx="8">
                  <c:v>3.375717904164331</c:v>
                </c:pt>
                <c:pt idx="9">
                  <c:v>3.302770657240282</c:v>
                </c:pt>
                <c:pt idx="10">
                  <c:v>3.114073660198568</c:v>
                </c:pt>
                <c:pt idx="11">
                  <c:v>3.114073660198568</c:v>
                </c:pt>
                <c:pt idx="12">
                  <c:v>2.262012673666569</c:v>
                </c:pt>
                <c:pt idx="13">
                  <c:v>2.166215625343519</c:v>
                </c:pt>
                <c:pt idx="14">
                  <c:v>1.950781977329818</c:v>
                </c:pt>
                <c:pt idx="15">
                  <c:v>1.578396073130169</c:v>
                </c:pt>
              </c:numCache>
            </c:numRef>
          </c:val>
        </c:ser>
        <c:ser>
          <c:idx val="1"/>
          <c:order val="1"/>
          <c:tx>
            <c:strRef>
              <c:f>'Molecular and Cellular Function'!$G$3</c:f>
              <c:strCache>
                <c:ptCount val="1"/>
              </c:strCache>
            </c:strRef>
          </c:tx>
          <c:spPr>
            <a:noFill/>
            <a:ln>
              <a:noFill/>
            </a:ln>
          </c:spPr>
          <c:invertIfNegative val="0"/>
          <c:trendline>
            <c:spPr>
              <a:ln w="22225">
                <a:solidFill>
                  <a:srgbClr val="FF0000"/>
                </a:solidFill>
                <a:prstDash val="dash"/>
              </a:ln>
            </c:spPr>
            <c:trendlineType val="linear"/>
            <c:dispRSqr val="0"/>
            <c:dispEq val="0"/>
          </c:trendline>
          <c:cat>
            <c:strRef>
              <c:f>'Molecular and Cellular Function'!$E$4:$E$19</c:f>
              <c:strCache>
                <c:ptCount val="16"/>
                <c:pt idx="0">
                  <c:v>Cellular Growth and Proliferation</c:v>
                </c:pt>
                <c:pt idx="1">
                  <c:v>Cell Death and Survival</c:v>
                </c:pt>
                <c:pt idx="2">
                  <c:v>Post-Translational Modification</c:v>
                </c:pt>
                <c:pt idx="3">
                  <c:v>Cellular Assembly and Organization</c:v>
                </c:pt>
                <c:pt idx="4">
                  <c:v>Cellular Function and Maintenance</c:v>
                </c:pt>
                <c:pt idx="5">
                  <c:v>Gene Expression</c:v>
                </c:pt>
                <c:pt idx="6">
                  <c:v>Cell Cycle</c:v>
                </c:pt>
                <c:pt idx="7">
                  <c:v>Cellular Movement</c:v>
                </c:pt>
                <c:pt idx="8">
                  <c:v>Cellular Development</c:v>
                </c:pt>
                <c:pt idx="9">
                  <c:v>Cell Signalling</c:v>
                </c:pt>
                <c:pt idx="10">
                  <c:v>Protein Degradation</c:v>
                </c:pt>
                <c:pt idx="11">
                  <c:v>Protein Synthesis</c:v>
                </c:pt>
                <c:pt idx="12">
                  <c:v>Cellular Compromise</c:v>
                </c:pt>
                <c:pt idx="13">
                  <c:v>DNA Rep., Recomb. and Repair</c:v>
                </c:pt>
                <c:pt idx="14">
                  <c:v>Cell Morphology</c:v>
                </c:pt>
                <c:pt idx="15">
                  <c:v>Cell-To-Cell Signalling and Interaction</c:v>
                </c:pt>
              </c:strCache>
            </c:strRef>
          </c:cat>
          <c:val>
            <c:numRef>
              <c:f>'Molecular and Cellular Function'!$G$4:$G$19</c:f>
              <c:numCache>
                <c:formatCode>General</c:formatCode>
                <c:ptCount val="16"/>
                <c:pt idx="0">
                  <c:v>1.301029995663981</c:v>
                </c:pt>
                <c:pt idx="1">
                  <c:v>1.301029995663981</c:v>
                </c:pt>
                <c:pt idx="2">
                  <c:v>1.301029995663981</c:v>
                </c:pt>
                <c:pt idx="3">
                  <c:v>1.301029995663981</c:v>
                </c:pt>
                <c:pt idx="4">
                  <c:v>1.301029995663981</c:v>
                </c:pt>
                <c:pt idx="5">
                  <c:v>1.301029995663981</c:v>
                </c:pt>
                <c:pt idx="6">
                  <c:v>1.301029995663981</c:v>
                </c:pt>
                <c:pt idx="7">
                  <c:v>1.301029995663981</c:v>
                </c:pt>
                <c:pt idx="8">
                  <c:v>1.301029995663981</c:v>
                </c:pt>
                <c:pt idx="9">
                  <c:v>1.301029995663981</c:v>
                </c:pt>
                <c:pt idx="10">
                  <c:v>1.301029995663981</c:v>
                </c:pt>
                <c:pt idx="11">
                  <c:v>1.301029995663981</c:v>
                </c:pt>
                <c:pt idx="12">
                  <c:v>1.301029995663981</c:v>
                </c:pt>
                <c:pt idx="13">
                  <c:v>1.301029995663981</c:v>
                </c:pt>
                <c:pt idx="14">
                  <c:v>1.301029995663981</c:v>
                </c:pt>
                <c:pt idx="15">
                  <c:v>1.3010299956639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38015144"/>
        <c:axId val="-2138011944"/>
      </c:barChart>
      <c:catAx>
        <c:axId val="-2138015144"/>
        <c:scaling>
          <c:orientation val="maxMin"/>
        </c:scaling>
        <c:delete val="0"/>
        <c:axPos val="l"/>
        <c:majorTickMark val="cross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r">
              <a:defRPr sz="8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38011944"/>
        <c:crosses val="autoZero"/>
        <c:auto val="1"/>
        <c:lblAlgn val="ctr"/>
        <c:lblOffset val="100"/>
        <c:noMultiLvlLbl val="0"/>
      </c:catAx>
      <c:valAx>
        <c:axId val="-2138011944"/>
        <c:scaling>
          <c:orientation val="minMax"/>
        </c:scaling>
        <c:delete val="0"/>
        <c:axPos val="t"/>
        <c:majorGridlines>
          <c:spPr>
            <a:ln>
              <a:solidFill>
                <a:schemeClr val="tx1"/>
              </a:solidFill>
              <a:prstDash val="dash"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38015144"/>
        <c:crosses val="autoZero"/>
        <c:crossBetween val="between"/>
      </c:valAx>
      <c:spPr>
        <a:solidFill>
          <a:schemeClr val="bg1">
            <a:lumMod val="85000"/>
          </a:schemeClr>
        </a:solidFill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3"/>
    </mc:Choice>
    <mc:Fallback>
      <c:style val="33"/>
    </mc:Fallback>
  </mc:AlternateContent>
  <c:chart>
    <c:title>
      <c:tx>
        <c:rich>
          <a:bodyPr/>
          <a:lstStyle/>
          <a:p>
            <a:pPr>
              <a:defRPr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000" b="0" dirty="0">
                <a:latin typeface="Arial" panose="020B0604020202020204" pitchFamily="34" charset="0"/>
                <a:cs typeface="Arial" panose="020B0604020202020204" pitchFamily="34" charset="0"/>
              </a:rPr>
              <a:t>-log(BH-corrected </a:t>
            </a:r>
            <a:r>
              <a:rPr lang="en-US" sz="1000" b="0" i="1" dirty="0">
                <a:latin typeface="Arial" panose="020B0604020202020204" pitchFamily="34" charset="0"/>
                <a:cs typeface="Arial" panose="020B0604020202020204" pitchFamily="34" charset="0"/>
              </a:rPr>
              <a:t>p-value</a:t>
            </a:r>
            <a:r>
              <a:rPr lang="en-US" sz="1000" b="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c:rich>
      </c:tx>
      <c:layout>
        <c:manualLayout>
          <c:xMode val="edge"/>
          <c:yMode val="edge"/>
          <c:x val="0.336750076941112"/>
          <c:y val="0.014939585844095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20311414944631"/>
          <c:y val="0.135999049909609"/>
          <c:w val="0.177996390245321"/>
          <c:h val="0.831659910236831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Disease (whole RNA-seq)'!$F$3</c:f>
              <c:strCache>
                <c:ptCount val="1"/>
                <c:pt idx="0">
                  <c:v>-log(BH-corrected p-value)</c:v>
                </c:pt>
              </c:strCache>
            </c:strRef>
          </c:tx>
          <c:invertIfNegative val="0"/>
          <c:cat>
            <c:strRef>
              <c:f>'Disease (whole RNA-seq)'!$E$4:$E$18</c:f>
              <c:strCache>
                <c:ptCount val="15"/>
                <c:pt idx="0">
                  <c:v>Cancer</c:v>
                </c:pt>
                <c:pt idx="1">
                  <c:v>Gastrointestinal Disease</c:v>
                </c:pt>
                <c:pt idx="2">
                  <c:v>Organismal Injury and Abnormalities</c:v>
                </c:pt>
                <c:pt idx="3">
                  <c:v>Reproductive System Disease</c:v>
                </c:pt>
                <c:pt idx="4">
                  <c:v>Infectious Disease</c:v>
                </c:pt>
                <c:pt idx="5">
                  <c:v>Renal and Urological Disease</c:v>
                </c:pt>
                <c:pt idx="6">
                  <c:v>Cardiovascular Disease</c:v>
                </c:pt>
                <c:pt idx="7">
                  <c:v>Connective Tissue Disorders</c:v>
                </c:pt>
                <c:pt idx="8">
                  <c:v>Developmental Disorders</c:v>
                </c:pt>
                <c:pt idx="9">
                  <c:v>Skeletal and Muscular Disorders</c:v>
                </c:pt>
                <c:pt idx="10">
                  <c:v>Hematological Disease</c:v>
                </c:pt>
                <c:pt idx="11">
                  <c:v>Immunological Disease</c:v>
                </c:pt>
                <c:pt idx="12">
                  <c:v>Hereditary Disorder</c:v>
                </c:pt>
                <c:pt idx="13">
                  <c:v>Respiratory Disease</c:v>
                </c:pt>
                <c:pt idx="14">
                  <c:v>Neurological Disease</c:v>
                </c:pt>
              </c:strCache>
            </c:strRef>
          </c:cat>
          <c:val>
            <c:numRef>
              <c:f>'Disease (whole RNA-seq)'!$F$4:$F$18</c:f>
              <c:numCache>
                <c:formatCode>General</c:formatCode>
                <c:ptCount val="15"/>
                <c:pt idx="0">
                  <c:v>6.120904120499874</c:v>
                </c:pt>
                <c:pt idx="1">
                  <c:v>4.928117992693874</c:v>
                </c:pt>
                <c:pt idx="2">
                  <c:v>3.206209615309179</c:v>
                </c:pt>
                <c:pt idx="3">
                  <c:v>3.206209615309179</c:v>
                </c:pt>
                <c:pt idx="4">
                  <c:v>2.801342913045576</c:v>
                </c:pt>
                <c:pt idx="5">
                  <c:v>2.801342913045576</c:v>
                </c:pt>
                <c:pt idx="6">
                  <c:v>2.447331783887807</c:v>
                </c:pt>
                <c:pt idx="7">
                  <c:v>2.096910013008054</c:v>
                </c:pt>
                <c:pt idx="8">
                  <c:v>2.096910013008054</c:v>
                </c:pt>
                <c:pt idx="9">
                  <c:v>2.096910013008054</c:v>
                </c:pt>
                <c:pt idx="10">
                  <c:v>2.077793722560984</c:v>
                </c:pt>
                <c:pt idx="11">
                  <c:v>1.473660722610156</c:v>
                </c:pt>
                <c:pt idx="12">
                  <c:v>1.471083299722345</c:v>
                </c:pt>
                <c:pt idx="13">
                  <c:v>1.405607449624573</c:v>
                </c:pt>
                <c:pt idx="14">
                  <c:v>1.357535479757878</c:v>
                </c:pt>
              </c:numCache>
            </c:numRef>
          </c:val>
        </c:ser>
        <c:ser>
          <c:idx val="1"/>
          <c:order val="1"/>
          <c:tx>
            <c:strRef>
              <c:f>'Disease (whole RNA-seq)'!$G$3</c:f>
              <c:strCache>
                <c:ptCount val="1"/>
              </c:strCache>
            </c:strRef>
          </c:tx>
          <c:spPr>
            <a:noFill/>
            <a:ln>
              <a:noFill/>
            </a:ln>
          </c:spPr>
          <c:invertIfNegative val="0"/>
          <c:trendline>
            <c:spPr>
              <a:ln w="22225">
                <a:solidFill>
                  <a:srgbClr val="FF0000"/>
                </a:solidFill>
                <a:prstDash val="dash"/>
              </a:ln>
            </c:spPr>
            <c:trendlineType val="linear"/>
            <c:dispRSqr val="0"/>
            <c:dispEq val="0"/>
          </c:trendline>
          <c:cat>
            <c:strRef>
              <c:f>'Disease (whole RNA-seq)'!$E$4:$E$18</c:f>
              <c:strCache>
                <c:ptCount val="15"/>
                <c:pt idx="0">
                  <c:v>Cancer</c:v>
                </c:pt>
                <c:pt idx="1">
                  <c:v>Gastrointestinal Disease</c:v>
                </c:pt>
                <c:pt idx="2">
                  <c:v>Organismal Injury and Abnormalities</c:v>
                </c:pt>
                <c:pt idx="3">
                  <c:v>Reproductive System Disease</c:v>
                </c:pt>
                <c:pt idx="4">
                  <c:v>Infectious Disease</c:v>
                </c:pt>
                <c:pt idx="5">
                  <c:v>Renal and Urological Disease</c:v>
                </c:pt>
                <c:pt idx="6">
                  <c:v>Cardiovascular Disease</c:v>
                </c:pt>
                <c:pt idx="7">
                  <c:v>Connective Tissue Disorders</c:v>
                </c:pt>
                <c:pt idx="8">
                  <c:v>Developmental Disorders</c:v>
                </c:pt>
                <c:pt idx="9">
                  <c:v>Skeletal and Muscular Disorders</c:v>
                </c:pt>
                <c:pt idx="10">
                  <c:v>Hematological Disease</c:v>
                </c:pt>
                <c:pt idx="11">
                  <c:v>Immunological Disease</c:v>
                </c:pt>
                <c:pt idx="12">
                  <c:v>Hereditary Disorder</c:v>
                </c:pt>
                <c:pt idx="13">
                  <c:v>Respiratory Disease</c:v>
                </c:pt>
                <c:pt idx="14">
                  <c:v>Neurological Disease</c:v>
                </c:pt>
              </c:strCache>
            </c:strRef>
          </c:cat>
          <c:val>
            <c:numRef>
              <c:f>'Disease (whole RNA-seq)'!$G$4:$G$18</c:f>
              <c:numCache>
                <c:formatCode>General</c:formatCode>
                <c:ptCount val="15"/>
                <c:pt idx="0">
                  <c:v>1.301029995663981</c:v>
                </c:pt>
                <c:pt idx="1">
                  <c:v>1.301029995663981</c:v>
                </c:pt>
                <c:pt idx="2">
                  <c:v>1.301029995663981</c:v>
                </c:pt>
                <c:pt idx="3">
                  <c:v>1.301029995663981</c:v>
                </c:pt>
                <c:pt idx="4">
                  <c:v>1.301029995663981</c:v>
                </c:pt>
                <c:pt idx="5">
                  <c:v>1.301029995663981</c:v>
                </c:pt>
                <c:pt idx="6">
                  <c:v>1.301029995663981</c:v>
                </c:pt>
                <c:pt idx="7">
                  <c:v>1.301029995663981</c:v>
                </c:pt>
                <c:pt idx="8">
                  <c:v>1.301029995663981</c:v>
                </c:pt>
                <c:pt idx="9">
                  <c:v>1.301029995663981</c:v>
                </c:pt>
                <c:pt idx="10">
                  <c:v>1.301029995663981</c:v>
                </c:pt>
                <c:pt idx="11">
                  <c:v>1.301029995663981</c:v>
                </c:pt>
                <c:pt idx="12">
                  <c:v>1.301029995663981</c:v>
                </c:pt>
                <c:pt idx="13">
                  <c:v>1.301029995663981</c:v>
                </c:pt>
                <c:pt idx="14">
                  <c:v>1.3010299956639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41033080"/>
        <c:axId val="2140407000"/>
      </c:barChart>
      <c:catAx>
        <c:axId val="2141033080"/>
        <c:scaling>
          <c:orientation val="maxMin"/>
        </c:scaling>
        <c:delete val="0"/>
        <c:axPos val="l"/>
        <c:majorTickMark val="cross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0407000"/>
        <c:crosses val="autoZero"/>
        <c:auto val="1"/>
        <c:lblAlgn val="ctr"/>
        <c:lblOffset val="100"/>
        <c:noMultiLvlLbl val="0"/>
      </c:catAx>
      <c:valAx>
        <c:axId val="2140407000"/>
        <c:scaling>
          <c:orientation val="minMax"/>
        </c:scaling>
        <c:delete val="0"/>
        <c:axPos val="t"/>
        <c:majorGridlines>
          <c:spPr>
            <a:ln>
              <a:solidFill>
                <a:schemeClr val="tx1"/>
              </a:solidFill>
              <a:prstDash val="dash"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1033080"/>
        <c:crosses val="autoZero"/>
        <c:crossBetween val="between"/>
        <c:majorUnit val="2.0"/>
      </c:valAx>
      <c:spPr>
        <a:solidFill>
          <a:schemeClr val="bg1">
            <a:lumMod val="85000"/>
          </a:schemeClr>
        </a:solidFill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37BDB6-2217-458C-A464-411270E3D8BE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15907"/>
            <a:ext cx="533527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A9BE15-AA02-43E4-85E9-428C61B879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590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A9BE15-AA02-43E4-85E9-428C61B87907}" type="slidenum">
              <a:rPr lang="en-GB" smtClean="0"/>
              <a:pPr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10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A9BE15-AA02-43E4-85E9-428C61B87907}" type="slidenum">
              <a:rPr lang="en-GB" smtClean="0"/>
              <a:pPr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6724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  <a:prstGeom prst="rect">
            <a:avLst/>
          </a:prstGeo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>
            <a:lvl1pPr>
              <a:defRPr sz="1000"/>
            </a:lvl1pPr>
            <a:lvl2pPr>
              <a:defRPr sz="1000"/>
            </a:lvl2pPr>
            <a:lvl3pPr>
              <a:defRPr sz="1000"/>
            </a:lvl3pPr>
            <a:lvl4pPr>
              <a:defRPr sz="1000"/>
            </a:lvl4pPr>
            <a:lvl5pPr>
              <a:defRPr sz="10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2656" y="272480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C96152-69FA-4092-99D9-1C64DDD04061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093FA-BFF7-4F5A-98EA-5EA44A7241F1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14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4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14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image" Target="../media/image2.emf"/><Relationship Id="rId6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4" Type="http://schemas.openxmlformats.org/officeDocument/2006/relationships/image" Target="../media/image16.tiff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tiff"/><Relationship Id="rId8" Type="http://schemas.openxmlformats.org/officeDocument/2006/relationships/image" Target="../media/image20.png"/><Relationship Id="rId9" Type="http://schemas.openxmlformats.org/officeDocument/2006/relationships/image" Target="../media/image21.png"/><Relationship Id="rId10" Type="http://schemas.openxmlformats.org/officeDocument/2006/relationships/image" Target="../media/image22.png"/><Relationship Id="rId11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4" Type="http://schemas.openxmlformats.org/officeDocument/2006/relationships/image" Target="../media/image31.emf"/><Relationship Id="rId5" Type="http://schemas.openxmlformats.org/officeDocument/2006/relationships/image" Target="../media/image32.png"/><Relationship Id="rId6" Type="http://schemas.openxmlformats.org/officeDocument/2006/relationships/image" Target="../media/image33.tiff"/><Relationship Id="rId7" Type="http://schemas.openxmlformats.org/officeDocument/2006/relationships/image" Target="../media/image34.png"/><Relationship Id="rId8" Type="http://schemas.openxmlformats.org/officeDocument/2006/relationships/image" Target="../media/image35.tiff"/><Relationship Id="rId9" Type="http://schemas.openxmlformats.org/officeDocument/2006/relationships/image" Target="../media/image36.jpeg"/><Relationship Id="rId10" Type="http://schemas.openxmlformats.org/officeDocument/2006/relationships/image" Target="../media/image37.jpeg"/><Relationship Id="rId11" Type="http://schemas.openxmlformats.org/officeDocument/2006/relationships/image" Target="../media/image38.tif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0796" y="0"/>
            <a:ext cx="2944098" cy="2316161"/>
          </a:xfrm>
          <a:prstGeom prst="rect">
            <a:avLst/>
          </a:prstGeom>
        </p:spPr>
      </p:pic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4600627"/>
              </p:ext>
            </p:extLst>
          </p:nvPr>
        </p:nvGraphicFramePr>
        <p:xfrm>
          <a:off x="1739844" y="2836704"/>
          <a:ext cx="6490661" cy="35000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-643058" y="2424933"/>
            <a:ext cx="6329516" cy="3851341"/>
            <a:chOff x="-767509" y="52893"/>
            <a:chExt cx="6329516" cy="3851341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7855805"/>
                </p:ext>
              </p:extLst>
            </p:nvPr>
          </p:nvGraphicFramePr>
          <p:xfrm>
            <a:off x="-767509" y="503872"/>
            <a:ext cx="6329516" cy="34003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1732436" y="52893"/>
              <a:ext cx="9140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/>
                <a:t>Disease</a:t>
              </a: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577320" y="2278529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462527" y="0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708400" y="2276974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0" y="9213535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SUPPLEMENTARY </a:t>
            </a:r>
            <a:r>
              <a:rPr lang="en-US" sz="4400" dirty="0" smtClean="0"/>
              <a:t>FIGURE 1</a:t>
            </a:r>
            <a:endParaRPr lang="en-US" sz="4400" dirty="0"/>
          </a:p>
        </p:txBody>
      </p:sp>
      <p:sp>
        <p:nvSpPr>
          <p:cNvPr id="14" name="TextBox 13"/>
          <p:cNvSpPr txBox="1"/>
          <p:nvPr/>
        </p:nvSpPr>
        <p:spPr>
          <a:xfrm>
            <a:off x="4663587" y="2424933"/>
            <a:ext cx="2042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Molecular Functio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75771" y="6452987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2877" y="6898229"/>
            <a:ext cx="2051657" cy="239542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48619" y="6898231"/>
            <a:ext cx="2051657" cy="2395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07353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9213535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SUPPLEMENTARY </a:t>
            </a:r>
            <a:r>
              <a:rPr lang="en-US" sz="4400" dirty="0" smtClean="0"/>
              <a:t>FIGURE 2</a:t>
            </a:r>
            <a:endParaRPr lang="en-US" sz="4400" dirty="0"/>
          </a:p>
        </p:txBody>
      </p:sp>
      <p:pic>
        <p:nvPicPr>
          <p:cNvPr id="18" name="Picture 17" descr="Screen Shot 2015-11-25 at 11.20.34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99" y="636865"/>
            <a:ext cx="6243596" cy="5772667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310133" y="206744"/>
            <a:ext cx="516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589159" y="255764"/>
            <a:ext cx="516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882954" y="319552"/>
            <a:ext cx="516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C</a:t>
            </a:r>
            <a:endParaRPr lang="en-US" sz="2000" b="1" dirty="0"/>
          </a:p>
        </p:txBody>
      </p:sp>
      <p:pic>
        <p:nvPicPr>
          <p:cNvPr id="22" name="Picture 21" descr="G:\New Folder\New Folder\Arsenite in clones\controls\controls\naive dcp3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3295" y="6819566"/>
            <a:ext cx="2160187" cy="216026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3" descr="G:\picture for wip presentation\New Folder\Arsenite in clones\pabp\pabp untreated\untreated pabp\skov3 2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5754" y="6819566"/>
            <a:ext cx="2160588" cy="2160588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3385073" y="6424316"/>
            <a:ext cx="26268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E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20424" y="6469245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D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450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6111" y="407708"/>
            <a:ext cx="1677987" cy="166274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372" y="485340"/>
            <a:ext cx="1792049" cy="1586011"/>
          </a:xfrm>
          <a:prstGeom prst="rect">
            <a:avLst/>
          </a:prstGeom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5296" y="430774"/>
            <a:ext cx="1591724" cy="16263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" name="TextBox 52"/>
          <p:cNvSpPr txBox="1"/>
          <p:nvPr/>
        </p:nvSpPr>
        <p:spPr>
          <a:xfrm>
            <a:off x="475342" y="246108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557719" y="246108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336933" y="129215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CAR8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896645" y="141915"/>
            <a:ext cx="705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812" y="4987218"/>
            <a:ext cx="2912831" cy="19141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7144" y="4982546"/>
            <a:ext cx="2912831" cy="19141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712" r="6715"/>
          <a:stretch/>
        </p:blipFill>
        <p:spPr bwMode="auto">
          <a:xfrm>
            <a:off x="670690" y="2626393"/>
            <a:ext cx="2353433" cy="2045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" name="Picture 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468"/>
          <a:stretch/>
        </p:blipFill>
        <p:spPr bwMode="auto">
          <a:xfrm>
            <a:off x="3601834" y="2481811"/>
            <a:ext cx="2553655" cy="22368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5" name="TextBox 54"/>
          <p:cNvSpPr txBox="1"/>
          <p:nvPr/>
        </p:nvSpPr>
        <p:spPr>
          <a:xfrm>
            <a:off x="518525" y="2170212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C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10064" y="465401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470573" y="465227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832357" y="2297145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CAR8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763669" y="2297145"/>
            <a:ext cx="705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0" y="9136559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SUPPLEMENTARY </a:t>
            </a:r>
            <a:r>
              <a:rPr lang="en-US" sz="4400" dirty="0" smtClean="0"/>
              <a:t>FIGURE </a:t>
            </a:r>
            <a:r>
              <a:rPr lang="en-US" sz="4400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4688042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40" b="9406"/>
          <a:stretch/>
        </p:blipFill>
        <p:spPr>
          <a:xfrm>
            <a:off x="2443597" y="6140903"/>
            <a:ext cx="2047837" cy="2056538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34" b="8241"/>
          <a:stretch/>
        </p:blipFill>
        <p:spPr>
          <a:xfrm>
            <a:off x="4612423" y="6137955"/>
            <a:ext cx="2047837" cy="208851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76" y="6254337"/>
            <a:ext cx="2115076" cy="2313929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3124200" y="174931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26571" y="4202279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0" y="6103959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89152" y="6103959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491507" y="5796589"/>
            <a:ext cx="12426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clitaxel (1µM)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66743" y="5796589"/>
            <a:ext cx="1438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emcitabine (2µM)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063798" y="8226472"/>
            <a:ext cx="1284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EO4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0µM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162321" y="8226471"/>
            <a:ext cx="1284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O4 (25µM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69" b="8874"/>
          <a:stretch/>
        </p:blipFill>
        <p:spPr bwMode="auto">
          <a:xfrm>
            <a:off x="653143" y="4335846"/>
            <a:ext cx="2819761" cy="13974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333" b="9673"/>
          <a:stretch/>
        </p:blipFill>
        <p:spPr bwMode="auto">
          <a:xfrm>
            <a:off x="3705961" y="4145153"/>
            <a:ext cx="2819761" cy="1609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9" descr="SKOV3 graph annexin.tif"/>
          <p:cNvPicPr>
            <a:picLocks noChangeAspect="1"/>
          </p:cNvPicPr>
          <p:nvPr/>
        </p:nvPicPr>
        <p:blipFill>
          <a:blip r:embed="rId7"/>
          <a:srcRect l="17918" t="15213" r="22835" b="9486"/>
          <a:stretch>
            <a:fillRect/>
          </a:stretch>
        </p:blipFill>
        <p:spPr>
          <a:xfrm>
            <a:off x="406240" y="254765"/>
            <a:ext cx="1723809" cy="1473463"/>
          </a:xfrm>
          <a:prstGeom prst="rect">
            <a:avLst/>
          </a:prstGeom>
        </p:spPr>
      </p:pic>
      <p:pic>
        <p:nvPicPr>
          <p:cNvPr id="31" name="Picture 30" descr="annexin skov.png"/>
          <p:cNvPicPr/>
          <p:nvPr/>
        </p:nvPicPr>
        <p:blipFill>
          <a:blip r:embed="rId8" cstate="print"/>
          <a:srcRect t="60554"/>
          <a:stretch>
            <a:fillRect/>
          </a:stretch>
        </p:blipFill>
        <p:spPr>
          <a:xfrm>
            <a:off x="2513097" y="429619"/>
            <a:ext cx="4236964" cy="1266727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 flipH="1">
            <a:off x="2892517" y="154365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siControl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flipH="1">
            <a:off x="4171769" y="154365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siLARP1 (1)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flipH="1">
            <a:off x="5563632" y="154365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siLARP1 (2)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0" y="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239374" y="6689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653" r="49471"/>
          <a:stretch/>
        </p:blipFill>
        <p:spPr>
          <a:xfrm>
            <a:off x="-220129" y="1982018"/>
            <a:ext cx="3197632" cy="1819574"/>
          </a:xfrm>
          <a:prstGeom prst="rect">
            <a:avLst/>
          </a:prstGeom>
          <a:noFill/>
          <a:ln>
            <a:noFill/>
          </a:ln>
        </p:spPr>
      </p:pic>
      <p:sp>
        <p:nvSpPr>
          <p:cNvPr id="38" name="TextBox 37"/>
          <p:cNvSpPr txBox="1"/>
          <p:nvPr/>
        </p:nvSpPr>
        <p:spPr>
          <a:xfrm>
            <a:off x="-55678" y="1779669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3685" y="535999"/>
            <a:ext cx="400110" cy="70147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106064" y="535998"/>
            <a:ext cx="400110" cy="70147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225602" y="2083029"/>
            <a:ext cx="1665327" cy="1918516"/>
            <a:chOff x="1176668" y="3623962"/>
            <a:chExt cx="1665327" cy="1918516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76668" y="3623962"/>
              <a:ext cx="1665327" cy="1695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1496265" y="5280868"/>
              <a:ext cx="12426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clitaxel (1µM)</a:t>
              </a:r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5007377" y="2096664"/>
            <a:ext cx="1732072" cy="1921814"/>
            <a:chOff x="4177643" y="3620664"/>
            <a:chExt cx="1732072" cy="1921814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77643" y="3620664"/>
              <a:ext cx="1665327" cy="16983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>
              <a:off x="4471501" y="5280868"/>
              <a:ext cx="1438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emcitabine (2µM)</a:t>
              </a:r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0" y="9136559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 smtClean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8310301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1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483" y="3444240"/>
            <a:ext cx="3475702" cy="3362960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-40640" y="3399369"/>
            <a:ext cx="6228353" cy="3369835"/>
            <a:chOff x="-41897" y="4765713"/>
            <a:chExt cx="6228353" cy="3369835"/>
          </a:xfrm>
        </p:grpSpPr>
        <p:pic>
          <p:nvPicPr>
            <p:cNvPr id="25" name="Picture 2" descr="H:\My Files Imperial\Experiments\Clonogenic Assay (+Side Population)\DATA FOR PAPER\rough combined image.pn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482"/>
            <a:stretch/>
          </p:blipFill>
          <p:spPr bwMode="auto">
            <a:xfrm>
              <a:off x="4245623" y="4765713"/>
              <a:ext cx="1940833" cy="33698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-41897" y="5184923"/>
              <a:ext cx="933332" cy="2677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OV3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CAR8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5" name="Picture 5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3635" y="1244600"/>
            <a:ext cx="2816608" cy="199180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00835" y="1120210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03200" y="3279210"/>
            <a:ext cx="4046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B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0" y="9136559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SUPPLEMENTARY </a:t>
            </a:r>
            <a:r>
              <a:rPr lang="en-US" sz="4400" dirty="0" smtClean="0"/>
              <a:t>FIGURE </a:t>
            </a:r>
            <a:r>
              <a:rPr lang="en-US" sz="4400" dirty="0"/>
              <a:t>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64811" y="6805619"/>
            <a:ext cx="8930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16053" y="6805619"/>
            <a:ext cx="11524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iLARP1 (1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143813" y="6805619"/>
            <a:ext cx="11524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iLARP1 (2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5538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086435" y="3029964"/>
            <a:ext cx="2484460" cy="1557274"/>
            <a:chOff x="6980105" y="4346531"/>
            <a:chExt cx="2484460" cy="1557274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9903"/>
            <a:stretch/>
          </p:blipFill>
          <p:spPr>
            <a:xfrm>
              <a:off x="6980105" y="4346531"/>
              <a:ext cx="2484459" cy="115233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9491"/>
            <a:stretch/>
          </p:blipFill>
          <p:spPr>
            <a:xfrm>
              <a:off x="6980106" y="5510563"/>
              <a:ext cx="2484459" cy="39324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122125" y="3113742"/>
            <a:ext cx="2338524" cy="1495318"/>
            <a:chOff x="3135509" y="6723140"/>
            <a:chExt cx="2338524" cy="1495318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9776"/>
            <a:stretch/>
          </p:blipFill>
          <p:spPr>
            <a:xfrm>
              <a:off x="3135509" y="7853440"/>
              <a:ext cx="2338524" cy="365018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8096"/>
            <a:stretch/>
          </p:blipFill>
          <p:spPr>
            <a:xfrm>
              <a:off x="3135509" y="6723140"/>
              <a:ext cx="2338524" cy="1117266"/>
            </a:xfrm>
            <a:prstGeom prst="rect">
              <a:avLst/>
            </a:prstGeom>
          </p:spPr>
        </p:pic>
      </p:grpSp>
      <p:pic>
        <p:nvPicPr>
          <p:cNvPr id="18" name="Picture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8461" y="2978464"/>
            <a:ext cx="2182342" cy="164362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53000" y="4583884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CAR3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990360" y="4583884"/>
            <a:ext cx="80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GROV-1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03936" y="4528179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02369" y="13558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02370" y="263339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4250825"/>
              </p:ext>
            </p:extLst>
          </p:nvPr>
        </p:nvGraphicFramePr>
        <p:xfrm>
          <a:off x="527118" y="686337"/>
          <a:ext cx="5933934" cy="1473652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977978"/>
                <a:gridCol w="1977978"/>
                <a:gridCol w="1977978"/>
              </a:tblGrid>
              <a:tr h="557441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CD133+ population on flow </a:t>
                      </a:r>
                      <a:r>
                        <a:rPr lang="en-GB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metry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I60 relative expression (probe intensity – dataset minimum)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</a:tr>
              <a:tr h="228592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OV3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1%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28592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CAR8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1%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28592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CAR3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%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6</a:t>
                      </a:r>
                      <a:endParaRPr lang="en-GB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72" marR="5872" marT="5872" marB="0" anchor="b"/>
                </a:tc>
              </a:tr>
              <a:tr h="228592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ROV1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%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365" marR="56365" marT="28182" marB="28182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1</a:t>
                      </a:r>
                      <a:endParaRPr lang="en-GB" sz="1100" kern="1200" dirty="0" smtClean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872" marR="5872" marT="5872" marB="0" anchor="b"/>
                </a:tc>
              </a:tr>
            </a:tbl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0" y="9136559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SUPPLEMENTARY </a:t>
            </a:r>
            <a:r>
              <a:rPr lang="en-US" sz="4400" dirty="0" smtClean="0"/>
              <a:t>FIGURE </a:t>
            </a:r>
            <a:r>
              <a:rPr lang="en-US" sz="4400" dirty="0"/>
              <a:t>6</a:t>
            </a:r>
            <a:endParaRPr lang="en-US" sz="4400" dirty="0" smtClean="0"/>
          </a:p>
        </p:txBody>
      </p:sp>
    </p:spTree>
    <p:extLst>
      <p:ext uri="{BB962C8B-B14F-4D97-AF65-F5344CB8AC3E}">
        <p14:creationId xmlns:p14="http://schemas.microsoft.com/office/powerpoint/2010/main" val="24683145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70" t="12252" r="24116"/>
          <a:stretch/>
        </p:blipFill>
        <p:spPr>
          <a:xfrm>
            <a:off x="202883" y="3232915"/>
            <a:ext cx="1961328" cy="1908216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7527" y="254000"/>
            <a:ext cx="2163650" cy="286488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867" y="5372777"/>
            <a:ext cx="2769054" cy="245887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0" y="119172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30724" y="219567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B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0" y="3056604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D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0300" y="588898"/>
            <a:ext cx="2183250" cy="1755899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4371068" y="219567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C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70931" y="5439505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764654" y="5381237"/>
            <a:ext cx="2718298" cy="2425038"/>
            <a:chOff x="3257754" y="3152135"/>
            <a:chExt cx="2106547" cy="1879285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7754" y="3152135"/>
              <a:ext cx="2106547" cy="1879285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4240827" y="3428611"/>
              <a:ext cx="94939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310589" y="2807827"/>
            <a:ext cx="4269843" cy="2462762"/>
            <a:chOff x="-306523" y="5140008"/>
            <a:chExt cx="4269843" cy="2462762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60" t="17859" r="21184"/>
            <a:stretch/>
          </p:blipFill>
          <p:spPr>
            <a:xfrm>
              <a:off x="0" y="5555920"/>
              <a:ext cx="2233857" cy="1888748"/>
            </a:xfrm>
            <a:prstGeom prst="rect">
              <a:avLst/>
            </a:prstGeom>
          </p:spPr>
        </p:pic>
        <p:pic>
          <p:nvPicPr>
            <p:cNvPr id="17" name="Picture 2" descr="H:\My Files Imperial\Experiments\Immunohistochemistry\Third Ovarian TMA (Mona)\Mucinous images\Mucinous carcinoma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307137" y="6368460"/>
              <a:ext cx="1369412" cy="1026988"/>
            </a:xfrm>
            <a:prstGeom prst="rect">
              <a:avLst/>
            </a:prstGeom>
            <a:noFill/>
          </p:spPr>
        </p:pic>
        <p:pic>
          <p:nvPicPr>
            <p:cNvPr id="19" name="Picture 3" descr="H:\My Files Imperial\Experiments\Immunohistochemistry\Third Ovarian TMA (Mona)\Mucinous images\benign mucinous (taken with 50x objective on Nikon Eclipse TE2000-U) with Q Imaging micropublisher 5.0 RTV image capture and Image Pro Plus software)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307137" y="5140008"/>
              <a:ext cx="1369412" cy="1026988"/>
            </a:xfrm>
            <a:prstGeom prst="rect">
              <a:avLst/>
            </a:prstGeom>
            <a:noFill/>
          </p:spPr>
        </p:pic>
        <p:sp>
          <p:nvSpPr>
            <p:cNvPr id="20" name="TextBox 19"/>
            <p:cNvSpPr txBox="1"/>
            <p:nvPr/>
          </p:nvSpPr>
          <p:spPr>
            <a:xfrm>
              <a:off x="2235128" y="6122719"/>
              <a:ext cx="172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Benign mucinous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163121" y="7325771"/>
              <a:ext cx="172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Mucinous carcinoma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-306523" y="5451739"/>
              <a:ext cx="653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3348571" y="5452205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0" y="9136559"/>
            <a:ext cx="64490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SUPPLEMENTARY </a:t>
            </a:r>
            <a:r>
              <a:rPr lang="en-US" sz="4400" dirty="0" smtClean="0"/>
              <a:t>FIGURE </a:t>
            </a:r>
            <a:r>
              <a:rPr lang="en-US" sz="4400" dirty="0"/>
              <a:t>7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4218" y="655022"/>
            <a:ext cx="2292794" cy="1572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39496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870</TotalTime>
  <Words>175</Words>
  <Application>Microsoft Macintosh PowerPoint</Application>
  <PresentationFormat>A4 Paper (210x297 mm)</PresentationFormat>
  <Paragraphs>95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hopkins</dc:creator>
  <cp:lastModifiedBy>Sarah Blagden</cp:lastModifiedBy>
  <cp:revision>7516</cp:revision>
  <cp:lastPrinted>2014-12-15T12:53:23Z</cp:lastPrinted>
  <dcterms:created xsi:type="dcterms:W3CDTF">2013-08-21T15:29:43Z</dcterms:created>
  <dcterms:modified xsi:type="dcterms:W3CDTF">2015-12-16T17:47:45Z</dcterms:modified>
</cp:coreProperties>
</file>